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57" r:id="rId4"/>
    <p:sldId id="258" r:id="rId5"/>
    <p:sldId id="259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0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12" descr="C:\Users\mvuser\AppData\Local\Microsoft\Windows\Temporary Internet Files\Content.Word\Slide12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282" y="1000108"/>
            <a:ext cx="3942828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1" descr="C:\Users\mvuser\AppData\Local\Microsoft\Windows\Temporary Internet Files\Content.Word\new stick-7.3.14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643438" y="1071546"/>
            <a:ext cx="4036814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3"/>
          <p:cNvSpPr/>
          <p:nvPr/>
        </p:nvSpPr>
        <p:spPr>
          <a:xfrm>
            <a:off x="996652" y="2564904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5138686" y="2428868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996652" y="1340768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483768" y="1412776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T2DM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27784" y="2564904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FU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511672" y="162880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ontrol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9060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3108" y="3357562"/>
            <a:ext cx="4353606" cy="30718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9" descr="C:\Users\mvuser\AppData\Local\Microsoft\Windows\Temporary Internet Files\Content.Word\Slide7.jpg"/>
          <p:cNvPicPr>
            <a:picLocks noChangeAspect="1" noChangeArrowheads="1"/>
          </p:cNvPicPr>
          <p:nvPr/>
        </p:nvPicPr>
        <p:blipFill>
          <a:blip r:embed="rId3"/>
          <a:srcRect r="4216"/>
          <a:stretch>
            <a:fillRect/>
          </a:stretch>
        </p:blipFill>
        <p:spPr bwMode="auto">
          <a:xfrm>
            <a:off x="142844" y="142852"/>
            <a:ext cx="3837242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15" descr="C:\Users\mvuser\AppData\Local\Microsoft\Windows\Temporary Internet Files\Content.Word\Slide8.jp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214810" y="142852"/>
            <a:ext cx="3817964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Rectangle 1"/>
          <p:cNvSpPr/>
          <p:nvPr/>
        </p:nvSpPr>
        <p:spPr>
          <a:xfrm>
            <a:off x="539552" y="1196752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4644008" y="1511990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568302" y="4437112"/>
            <a:ext cx="1368152" cy="864096"/>
          </a:xfrm>
          <a:prstGeom prst="rect">
            <a:avLst/>
          </a:prstGeom>
          <a:noFill/>
          <a:ln w="12700">
            <a:solidFill>
              <a:schemeClr val="bg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679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743200"/>
            <a:ext cx="4403673" cy="8239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 rot="18725401">
            <a:off x="1814802" y="2169175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4" name="TextBox 3"/>
          <p:cNvSpPr txBox="1"/>
          <p:nvPr/>
        </p:nvSpPr>
        <p:spPr>
          <a:xfrm rot="18725401">
            <a:off x="2896045" y="2169306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971800"/>
            <a:ext cx="3836377" cy="733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 rot="18725401">
            <a:off x="6155016" y="2473975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 rot="18725401">
            <a:off x="7236259" y="2474106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312989" y="1383268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aspase</a:t>
            </a:r>
            <a:r>
              <a:rPr lang="en-US" dirty="0" smtClean="0"/>
              <a:t> 3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580189" y="1371600"/>
            <a:ext cx="1121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eta actin</a:t>
            </a:r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1600200" y="1828215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6096000" y="1828800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5553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743200"/>
            <a:ext cx="2871788" cy="685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 rot="18725401">
            <a:off x="1790989" y="2169175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4" name="TextBox 3"/>
          <p:cNvSpPr txBox="1"/>
          <p:nvPr/>
        </p:nvSpPr>
        <p:spPr>
          <a:xfrm rot="18725401">
            <a:off x="2682305" y="2169306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55789" y="1383268"/>
            <a:ext cx="560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X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143000" y="1828215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664897"/>
            <a:ext cx="2673025" cy="6138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 rot="18725401">
            <a:off x="5900372" y="2245375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 rot="18725401">
            <a:off x="6626659" y="2245506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741989" y="1371600"/>
            <a:ext cx="1121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eta actin</a:t>
            </a:r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5257800" y="1828800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01486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438400"/>
            <a:ext cx="2887809" cy="6905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 rot="18725401">
            <a:off x="1943389" y="2005107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4" name="TextBox 3"/>
          <p:cNvSpPr txBox="1"/>
          <p:nvPr/>
        </p:nvSpPr>
        <p:spPr>
          <a:xfrm rot="18725401">
            <a:off x="2834705" y="2005238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08189" y="1219200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if1 alpha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295400" y="1664147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3727" y="2657475"/>
            <a:ext cx="2621473" cy="471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 rot="18725401">
            <a:off x="5747972" y="2169175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 rot="18725401">
            <a:off x="6474259" y="2169306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589589" y="1295400"/>
            <a:ext cx="1121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eta actin</a:t>
            </a:r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5105400" y="1752600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5914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3130261"/>
            <a:ext cx="3429000" cy="6368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 rot="18725401">
            <a:off x="1257589" y="2462307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4" name="TextBox 3"/>
          <p:cNvSpPr txBox="1"/>
          <p:nvPr/>
        </p:nvSpPr>
        <p:spPr>
          <a:xfrm rot="18725401">
            <a:off x="2148905" y="2462438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60589" y="1676400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447800" y="2121347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3156609"/>
            <a:ext cx="2789872" cy="697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 rot="18725401">
            <a:off x="5243802" y="2614707"/>
            <a:ext cx="1124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 rot="18725401">
            <a:off x="6135118" y="2614838"/>
            <a:ext cx="8018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DFU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146802" y="1828800"/>
            <a:ext cx="1121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eta actin</a:t>
            </a:r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5434013" y="2273747"/>
            <a:ext cx="2438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919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33</Words>
  <Application>Microsoft Office PowerPoint</Application>
  <PresentationFormat>On-screen Show (4:3)</PresentationFormat>
  <Paragraphs>27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10</cp:revision>
  <dcterms:created xsi:type="dcterms:W3CDTF">2006-08-16T00:00:00Z</dcterms:created>
  <dcterms:modified xsi:type="dcterms:W3CDTF">2021-06-05T14:16:38Z</dcterms:modified>
</cp:coreProperties>
</file>